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78" d="100"/>
          <a:sy n="78" d="100"/>
        </p:scale>
        <p:origin x="82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FA9B24-F117-43F1-9A03-0272547328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DF2CBC-E7BB-6770-575D-87DA509BC0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6FC625-D09C-977C-DFBA-2EEE100F9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4180AA-5111-0D17-D774-4B992BB37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F92C4-5989-C9E4-BA62-FCA9F09AE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46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CA75D0-5BEB-088F-0D0B-09DF6CF8B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94C88C-4D5F-292B-39B1-9423B0A602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D3B651-E17C-FD1B-A9C5-1C92ECF0A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30BD94-3AB9-1643-3481-2E5F47F0C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FC2FA5-7C6A-9358-AB18-31D1EE1B2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981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D29277-0C4B-D63C-4836-537A3F764A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234A88-7972-84BD-3DB6-703C923E6E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7C2D56-B54A-4382-308C-7311B7AC6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FFC91-E14E-18E4-9790-B758C93CE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377AC-109C-896E-3258-6F17E725D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93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BBFEF-CAC3-C656-61C1-54C4F171A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181BCC-BAED-7FF1-D269-7D9883E73D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5CDF94-4CBB-31D4-150B-7DECA8F4D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F4F9E6-2B7D-2E51-64AF-DAAFA90B2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BB4834-A9AB-EBC9-8A33-402E53EA8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061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91055-6719-CD4C-347B-B7163A1AB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686ABB-9893-3F2F-20A7-BC8C3C292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3021C4-9A52-3033-F6BD-B577DCCC3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1C715-3D7F-ACA5-0E9A-E4E0CF837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33090E-C4D3-26AE-6174-D8D0D2C04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99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11BAF-1A4A-DFA0-A297-A47910AEF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D08EF7-EE61-C848-0CB0-3D857F3923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6B98FB-5486-B92C-5F37-4ADECC1A7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25A3B5-32FA-A454-ED97-5875CA045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9B5E45-21FD-0410-3B13-34C3FEA95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7A31C6-724F-EADE-7C50-BB0FBD3B1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291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030C6-40E1-78C3-6E28-7B2149F56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8C7625-A47B-A91F-5CAE-4DDFD3BD58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FF1D57-163F-2C7E-2254-A65C8D4DE8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525C3D-5E0F-F8E2-DBCE-E3F0D8E8EF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8BEA96-2F72-5BF7-C8B5-99C5BD2423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CDC125-27C6-14F1-8087-561614232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6D7B8C-9825-72A6-2BC3-7A25D4DCC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1CA2BD-C577-6862-5CDB-59148AE8D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66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584D7-5D02-F635-8BBE-B0E32A0AA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FA92DC-EC89-DD34-49C9-E21F9B666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461374-3248-ACA2-1DCC-C77A06107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A800DF-4239-32E1-DAC3-27E84687D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30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EE639D-E028-2CFF-04CC-3BF01DE12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B683424-08E0-08E1-547A-2E6C765C1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2A6C73-310A-AA6B-9B58-45C8910EC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008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725913-1D25-B6F6-2251-7A87CEAF3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4DB813-8602-C832-72D5-6045331D7A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CF93E0-4132-2A4D-25E0-2F4BB98685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D7CCBE-0DA9-3AA8-FAC6-56A41450A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6A769C-4380-AAB1-CCCC-1FC85FA3D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318D1A-5A25-526E-6B45-B672AB7CC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18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828AE9-88C6-3E97-16D6-224698F64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BFE19C-9A66-1644-B4E2-9E44720CAD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00484B-379B-9DEC-29C1-C1338919F1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27E84C-68FB-8870-0275-97B8FA3E7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E763FD-EBA8-4CEC-7239-AC022C814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8F9103-B826-4EFD-9454-40CFD0CB7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091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F73F2C-A40C-9797-D88A-A44E524D6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934200-A0A8-6022-0A70-99C2ED56D5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0D1882-DEDB-2E5B-8E08-FD353E049B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5D5FEEA-08E3-4992-BCDF-688246520537}" type="datetimeFigureOut">
              <a:rPr lang="en-US" smtClean="0"/>
              <a:t>6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8DEA78-DB33-1331-BD09-1CB492BFC58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B3C8E-F0C7-2CC6-BB76-E44807A86B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950E06-88C6-4B9B-9448-9897BBF10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51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BE9A6-EECD-7D46-DAC3-B435BBFAC1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ry Figure 1A</a:t>
            </a:r>
          </a:p>
        </p:txBody>
      </p:sp>
      <p:pic>
        <p:nvPicPr>
          <p:cNvPr id="6" name="Content Placeholder 5" descr="A screenshot of a graph&#10;&#10;Description automatically generated">
            <a:extLst>
              <a:ext uri="{FF2B5EF4-FFF2-40B4-BE49-F238E27FC236}">
                <a16:creationId xmlns:a16="http://schemas.microsoft.com/office/drawing/2014/main" id="{74080E33-4F25-D51E-8747-76C7F61C6D9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7067" y="1481497"/>
            <a:ext cx="9785836" cy="9785836"/>
          </a:xfrm>
        </p:spPr>
      </p:pic>
    </p:spTree>
    <p:extLst>
      <p:ext uri="{BB962C8B-B14F-4D97-AF65-F5344CB8AC3E}">
        <p14:creationId xmlns:p14="http://schemas.microsoft.com/office/powerpoint/2010/main" val="2741444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84C937-05EB-D85F-3927-CCCEE7161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ry Figure 1B</a:t>
            </a:r>
          </a:p>
        </p:txBody>
      </p:sp>
      <p:pic>
        <p:nvPicPr>
          <p:cNvPr id="5" name="Content Placeholder 4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1A37A071-76FD-D4ED-7A3E-805763F9F4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8614" y="1690688"/>
            <a:ext cx="8664959" cy="8664959"/>
          </a:xfrm>
        </p:spPr>
      </p:pic>
    </p:spTree>
    <p:extLst>
      <p:ext uri="{BB962C8B-B14F-4D97-AF65-F5344CB8AC3E}">
        <p14:creationId xmlns:p14="http://schemas.microsoft.com/office/powerpoint/2010/main" val="3731155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4F792-E517-C321-2B18-9B76F66E0C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ry Figure 2A</a:t>
            </a:r>
          </a:p>
        </p:txBody>
      </p:sp>
      <p:pic>
        <p:nvPicPr>
          <p:cNvPr id="5" name="Content Placeholder 4" descr="A graph with red and blue dots&#10;&#10;Description automatically generated">
            <a:extLst>
              <a:ext uri="{FF2B5EF4-FFF2-40B4-BE49-F238E27FC236}">
                <a16:creationId xmlns:a16="http://schemas.microsoft.com/office/drawing/2014/main" id="{F6108C83-72D5-D43A-A763-BEB724A0B9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0331" y="1825625"/>
            <a:ext cx="4351338" cy="4351338"/>
          </a:xfrm>
        </p:spPr>
      </p:pic>
    </p:spTree>
    <p:extLst>
      <p:ext uri="{BB962C8B-B14F-4D97-AF65-F5344CB8AC3E}">
        <p14:creationId xmlns:p14="http://schemas.microsoft.com/office/powerpoint/2010/main" val="11123471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4D6B7-4935-669C-432C-A6CE954BAA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ry Figure 2B</a:t>
            </a:r>
          </a:p>
        </p:txBody>
      </p:sp>
      <p:pic>
        <p:nvPicPr>
          <p:cNvPr id="5" name="Content Placeholder 4" descr="A graph with purple and black dots&#10;&#10;Description automatically generated">
            <a:extLst>
              <a:ext uri="{FF2B5EF4-FFF2-40B4-BE49-F238E27FC236}">
                <a16:creationId xmlns:a16="http://schemas.microsoft.com/office/drawing/2014/main" id="{C63E52D1-457E-D294-96DC-F0F8FCF6002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0331" y="1825625"/>
            <a:ext cx="4351338" cy="4351338"/>
          </a:xfrm>
        </p:spPr>
      </p:pic>
    </p:spTree>
    <p:extLst>
      <p:ext uri="{BB962C8B-B14F-4D97-AF65-F5344CB8AC3E}">
        <p14:creationId xmlns:p14="http://schemas.microsoft.com/office/powerpoint/2010/main" val="1707328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86B23-C1F0-4954-E7FF-062C1C4A1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l Figure 2C</a:t>
            </a:r>
          </a:p>
        </p:txBody>
      </p:sp>
      <p:pic>
        <p:nvPicPr>
          <p:cNvPr id="9" name="Content Placeholder 8" descr="A graph with a pink dot and black text&#10;&#10;Description automatically generated">
            <a:extLst>
              <a:ext uri="{FF2B5EF4-FFF2-40B4-BE49-F238E27FC236}">
                <a16:creationId xmlns:a16="http://schemas.microsoft.com/office/drawing/2014/main" id="{CEA1BB2B-F2D3-B957-CE51-3C3C8E26ACA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0331" y="1825625"/>
            <a:ext cx="4351338" cy="4351338"/>
          </a:xfrm>
        </p:spPr>
      </p:pic>
    </p:spTree>
    <p:extLst>
      <p:ext uri="{BB962C8B-B14F-4D97-AF65-F5344CB8AC3E}">
        <p14:creationId xmlns:p14="http://schemas.microsoft.com/office/powerpoint/2010/main" val="1801507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Supplementary Figure 1A</vt:lpstr>
      <vt:lpstr>Supplementary Figure 1B</vt:lpstr>
      <vt:lpstr>Supplementary Figure 2A</vt:lpstr>
      <vt:lpstr>Supplementary Figure 2B</vt:lpstr>
      <vt:lpstr>Supplemental Figure 2C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Amancherla, Kaushik V</dc:creator>
  <cp:lastModifiedBy>Amancherla, Kaushik V</cp:lastModifiedBy>
  <cp:revision>2</cp:revision>
  <dcterms:created xsi:type="dcterms:W3CDTF">2024-06-14T23:52:54Z</dcterms:created>
  <dcterms:modified xsi:type="dcterms:W3CDTF">2024-06-14T23:59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4-06-14T23:53:02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7cb355e7-8642-4132-95d7-ccd2ec3a7108</vt:lpwstr>
  </property>
  <property fmtid="{D5CDD505-2E9C-101B-9397-08002B2CF9AE}" pid="8" name="MSIP_Label_792c8cef-6f2b-4af1-b4ac-d815ff795cd6_ContentBits">
    <vt:lpwstr>0</vt:lpwstr>
  </property>
</Properties>
</file>